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60050"/>
    <a:srgbClr val="960059"/>
    <a:srgbClr val="920057"/>
    <a:srgbClr val="003969"/>
    <a:srgbClr val="65AA00"/>
    <a:srgbClr val="0092F7"/>
    <a:srgbClr val="AA0065"/>
    <a:srgbClr val="DA0082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4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Kidney health outcomes in children born very prematurely compared to full-term counterparts: a systematic review and meta-analysis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80182" y="1182267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evaluate the kidney health outcomes in ex-preterm children and adolescents (≤32 weeks of gestation)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4407E4-009E-18F9-F577-012EBA0C2DCD}"/>
              </a:ext>
            </a:extLst>
          </p:cNvPr>
          <p:cNvSpPr txBox="1"/>
          <p:nvPr/>
        </p:nvSpPr>
        <p:spPr>
          <a:xfrm>
            <a:off x="240291" y="1776173"/>
            <a:ext cx="4321318" cy="1169551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>
                <a:solidFill>
                  <a:srgbClr val="0065AA"/>
                </a:solidFill>
              </a:rPr>
              <a:t>DESIGN: </a:t>
            </a:r>
            <a:r>
              <a:rPr lang="en-US" sz="1400" dirty="0"/>
              <a:t>A systematic literature search through the major databases (MEDLINE/PubMed, Scopus, and Web of Science)</a:t>
            </a:r>
            <a:r>
              <a:rPr lang="el-GR" sz="1400" dirty="0"/>
              <a:t>.</a:t>
            </a:r>
            <a:r>
              <a:rPr lang="en-US" sz="1400" dirty="0"/>
              <a:t> Observational studies comparing kidney markers in children ≤32 weeks of gestation with full-term counterparts were included. </a:t>
            </a:r>
            <a:endParaRPr lang="en-GB" sz="16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Dokousli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8" y="5719172"/>
            <a:ext cx="7141846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550" b="1" dirty="0">
                <a:solidFill>
                  <a:schemeClr val="bg1"/>
                </a:solidFill>
              </a:rPr>
              <a:t>CONCLUSION</a:t>
            </a:r>
            <a:r>
              <a:rPr lang="en-GB" sz="1550" dirty="0">
                <a:solidFill>
                  <a:schemeClr val="bg1"/>
                </a:solidFill>
              </a:rPr>
              <a:t>: </a:t>
            </a:r>
            <a:r>
              <a:rPr lang="en-US" sz="1550" dirty="0">
                <a:solidFill>
                  <a:schemeClr val="bg1"/>
                </a:solidFill>
              </a:rPr>
              <a:t>This is the first systematic review and meta-analysis addressing the effect of prematurity ≤32 weeks of gestation on kidney function exclusively in children and adolescents. Elevated serum Cystatin C and SBP and lower Cr-eGFR may represent early markers of kidney dysfunction during childhood and adolescence. </a:t>
            </a:r>
            <a:endParaRPr lang="en-GB" sz="1550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5DE1238-F203-6DCB-13A3-6A5217C5DE0F}"/>
              </a:ext>
            </a:extLst>
          </p:cNvPr>
          <p:cNvSpPr txBox="1"/>
          <p:nvPr/>
        </p:nvSpPr>
        <p:spPr>
          <a:xfrm>
            <a:off x="9370567" y="3975943"/>
            <a:ext cx="2507073" cy="276999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1200" b="1" i="1" dirty="0">
                <a:effectLst/>
                <a:ea typeface="Arial" panose="020B0604020202020204" pitchFamily="34" charset="0"/>
              </a:rPr>
              <a:t>difference in serum Cystatin C levels </a:t>
            </a:r>
            <a:endParaRPr lang="el-GR" sz="1200" b="1" i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AC18BCD-7A20-38DB-0213-DAB6EB54382E}"/>
              </a:ext>
            </a:extLst>
          </p:cNvPr>
          <p:cNvSpPr txBox="1"/>
          <p:nvPr/>
        </p:nvSpPr>
        <p:spPr>
          <a:xfrm>
            <a:off x="240291" y="3294828"/>
            <a:ext cx="1665409" cy="276999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sz="1200" b="1" i="1" dirty="0">
                <a:effectLst/>
                <a:ea typeface="Arial" panose="020B0604020202020204" pitchFamily="34" charset="0"/>
              </a:rPr>
              <a:t>difference in Cr-eGFR </a:t>
            </a:r>
            <a:endParaRPr lang="el-GR" sz="1200" b="1" i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B65D08-A5D9-B5A1-075A-0E56630482CE}"/>
              </a:ext>
            </a:extLst>
          </p:cNvPr>
          <p:cNvSpPr txBox="1"/>
          <p:nvPr/>
        </p:nvSpPr>
        <p:spPr>
          <a:xfrm>
            <a:off x="7558687" y="4488876"/>
            <a:ext cx="4318954" cy="954107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pPr algn="just"/>
            <a:r>
              <a:rPr kumimoji="0" lang="en-GB" sz="1400" b="1" i="0" u="none" strike="noStrike" kern="1200" cap="none" spc="0" normalizeH="0" baseline="0" noProof="0" dirty="0">
                <a:ln>
                  <a:noFill/>
                </a:ln>
                <a:solidFill>
                  <a:srgbClr val="0065A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UTCOMES: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irteen studies (16 reports) comprising 2112 participants were included. The very preterm group had higher serum cystatin C, lower Cr-eGFR, and higher SBP compared to the full-term peers.</a:t>
            </a:r>
            <a:endParaRPr lang="el-GR" dirty="0"/>
          </a:p>
        </p:txBody>
      </p:sp>
      <p:pic>
        <p:nvPicPr>
          <p:cNvPr id="11" name="Εικόνα 10" descr="Εικόνα που περιέχει κείμενο, γραμματοσειρά, στιγμιότυπο οθόνης, διάγραμμα&#10;&#10;Το περιεχόμενο που δημιουργείται από τεχνολογία AI ενδέχεται να είναι εσφαλμένο.">
            <a:extLst>
              <a:ext uri="{FF2B5EF4-FFF2-40B4-BE49-F238E27FC236}">
                <a16:creationId xmlns:a16="http://schemas.microsoft.com/office/drawing/2014/main" id="{343BEB5E-65C4-C3CE-DC0B-B53D3B503D7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697" b="25735"/>
          <a:stretch/>
        </p:blipFill>
        <p:spPr>
          <a:xfrm>
            <a:off x="180182" y="3636602"/>
            <a:ext cx="6881979" cy="1916961"/>
          </a:xfrm>
          <a:prstGeom prst="rect">
            <a:avLst/>
          </a:prstGeom>
        </p:spPr>
      </p:pic>
      <p:pic>
        <p:nvPicPr>
          <p:cNvPr id="15" name="Εικόνα 14" descr="Εικόνα που περιέχει κείμενο, γραμματοσειρά, στιγμιότυπο οθόνης, διάγραμμα&#10;&#10;Το περιεχόμενο που δημιουργείται από τεχνολογία AI ενδέχεται να είναι εσφαλμένο.">
            <a:extLst>
              <a:ext uri="{FF2B5EF4-FFF2-40B4-BE49-F238E27FC236}">
                <a16:creationId xmlns:a16="http://schemas.microsoft.com/office/drawing/2014/main" id="{7A40B375-5BBF-32E0-C537-74C3EB48C0B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182" b="22273"/>
          <a:stretch/>
        </p:blipFill>
        <p:spPr>
          <a:xfrm>
            <a:off x="5133940" y="1630511"/>
            <a:ext cx="6743700" cy="2227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22</TotalTime>
  <Words>179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9</cp:revision>
  <dcterms:created xsi:type="dcterms:W3CDTF">2019-06-13T12:30:18Z</dcterms:created>
  <dcterms:modified xsi:type="dcterms:W3CDTF">2025-04-23T10:03:44Z</dcterms:modified>
</cp:coreProperties>
</file>